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0"/>
  </p:handoutMasterIdLst>
  <p:sldIdLst>
    <p:sldId id="264" r:id="rId2"/>
    <p:sldId id="263" r:id="rId3"/>
    <p:sldId id="269" r:id="rId4"/>
    <p:sldId id="272" r:id="rId5"/>
    <p:sldId id="270" r:id="rId6"/>
    <p:sldId id="268" r:id="rId7"/>
    <p:sldId id="271" r:id="rId8"/>
    <p:sldId id="265" r:id="rId9"/>
  </p:sldIdLst>
  <p:sldSz cx="6035675" cy="73152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38" autoAdjust="0"/>
    <p:restoredTop sz="94660"/>
  </p:normalViewPr>
  <p:slideViewPr>
    <p:cSldViewPr>
      <p:cViewPr varScale="1">
        <p:scale>
          <a:sx n="69" d="100"/>
          <a:sy n="69" d="100"/>
        </p:scale>
        <p:origin x="-2174" y="-82"/>
      </p:cViewPr>
      <p:guideLst>
        <p:guide orient="horz" pos="2304"/>
        <p:guide pos="190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1879E-756A-48EE-9B7C-C47D4DDDEBEA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EF3265-256D-4DE7-ADEF-B7E84A6D9B2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3320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2676" y="2272454"/>
            <a:ext cx="5130324" cy="15680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05351" y="4145280"/>
            <a:ext cx="4224973" cy="18694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5864" y="292948"/>
            <a:ext cx="1358027" cy="624162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1784" y="292948"/>
            <a:ext cx="3973486" cy="624162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6777" y="4700694"/>
            <a:ext cx="5130324" cy="145288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6777" y="3100495"/>
            <a:ext cx="5130324" cy="16001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1784" y="1706880"/>
            <a:ext cx="2665756" cy="48276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8135" y="1706880"/>
            <a:ext cx="2665756" cy="48276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1784" y="1637454"/>
            <a:ext cx="2666805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1784" y="2319867"/>
            <a:ext cx="2666805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66039" y="1637454"/>
            <a:ext cx="2667852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66039" y="2319867"/>
            <a:ext cx="2667852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1784" y="291253"/>
            <a:ext cx="1985695" cy="123952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59781" y="291254"/>
            <a:ext cx="3374110" cy="62433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1784" y="1530774"/>
            <a:ext cx="1985695" cy="50038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83035" y="5120640"/>
            <a:ext cx="3621405" cy="60452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83035" y="653627"/>
            <a:ext cx="3621405" cy="43891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83035" y="5725161"/>
            <a:ext cx="3621405" cy="8585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1784" y="292947"/>
            <a:ext cx="5432108" cy="1219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1784" y="1706880"/>
            <a:ext cx="5432108" cy="48276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1784" y="6780107"/>
            <a:ext cx="1408324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7A7FB-DE30-4731-96A7-05CD36B17556}" type="datetimeFigureOut">
              <a:rPr lang="en-US" smtClean="0"/>
              <a:pPr/>
              <a:t>5/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62189" y="6780107"/>
            <a:ext cx="1911297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5567" y="6780107"/>
            <a:ext cx="1408324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9E489-F12B-44A8-9C8A-185F02CFE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8437" y="152400"/>
            <a:ext cx="2568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. </a:t>
            </a:r>
            <a:endParaRPr lang="en-US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4637" y="838200"/>
            <a:ext cx="1905000" cy="28955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865437" y="838200"/>
            <a:ext cx="2867024" cy="289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7" name="TextBox 36"/>
          <p:cNvSpPr txBox="1"/>
          <p:nvPr/>
        </p:nvSpPr>
        <p:spPr>
          <a:xfrm>
            <a:off x="0" y="5334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560637" y="5334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69" name="Rectangle 1"/>
          <p:cNvSpPr>
            <a:spLocks noChangeArrowheads="1"/>
          </p:cNvSpPr>
          <p:nvPr/>
        </p:nvSpPr>
        <p:spPr bwMode="auto">
          <a:xfrm>
            <a:off x="198437" y="4115544"/>
            <a:ext cx="5598007" cy="28623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upplementary Figure 1. L1 and </a:t>
            </a:r>
            <a:r>
              <a:rPr kumimoji="0" lang="en-GB" altLang="zh-CN" sz="10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assay. A.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chematic of L1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plasmid (L1). ORF1 and ORF2 indicate open reading frames 1 and 2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encoded by the full-length L1. A white interrupted arrow corresponds to the  neomycin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sistance gene positioned in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h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ereverse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orientation relative to L1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ransciprit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. The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neomycin gene contains an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intr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that is spliced during L1 transcription. P is a promoter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driving neomycin gene expression (the direction of transcription is reversed relative to L1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ranscription). This feature ensures that a functional neomycin protein can only be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expressed, if </a:t>
            </a:r>
            <a:r>
              <a:rPr kumimoji="0" lang="en-GB" altLang="zh-CN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de novo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L1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occurs in the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ransfected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cells. Open circles indicate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L1 ORF1p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trimers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that associate with L1 mRNA. A scan of a flask is shown to demonstrate the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o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utput of the assay which is neomycin resistant colonies corresponding to </a:t>
            </a:r>
            <a:r>
              <a:rPr kumimoji="0" lang="en-GB" altLang="zh-CN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de novo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L1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r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etrotransposit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that occurred in cultured cells.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GB" altLang="zh-CN" sz="1000" dirty="0" smtClean="0">
              <a:latin typeface="Arial" pitchFamily="34" charset="0"/>
              <a:ea typeface="SimSun" pitchFamily="2" charset="-122"/>
              <a:cs typeface="Arial" pitchFamily="34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B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chematic of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plasmid (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). Neomycin resistance gene and promoter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driving its expression are shown as in A. 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Self splicing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intron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(SSI) is used to disrupt functional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neomycin expression. A SSI is used because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expression is driven by polymerase III. An L1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source is provided </a:t>
            </a:r>
            <a:r>
              <a:rPr lang="en-GB" altLang="zh-CN" sz="1000" i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in trans 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to drive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.  A scan of a flask is shown to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demonstrate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theoutput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of the assay which is neomycin resistant colonies corresponding to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i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de novo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that occurred in cultured cells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228600"/>
            <a:ext cx="2568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2</a:t>
            </a:r>
            <a:r>
              <a:rPr lang="en-US" b="1" dirty="0" smtClean="0"/>
              <a:t>. </a:t>
            </a:r>
            <a:endParaRPr lang="en-US" b="1" dirty="0"/>
          </a:p>
        </p:txBody>
      </p:sp>
      <p:pic>
        <p:nvPicPr>
          <p:cNvPr id="1027" name="Picture 3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8437" y="990600"/>
            <a:ext cx="4599432" cy="35844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20887" y="5105400"/>
            <a:ext cx="6014788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upplementary Figure 2. Toxicity is a colony formation assay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in mammalian cells transiently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cotransfected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with a neomycin expression plasmid (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Neo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) and with a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L1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or MT1 expression plasmids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and/or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an empty expression plasmid to measure any potential effects of L1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and/or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MT1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overexpress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on cell viability and colony formation. G418 selection results in selection of cells acquired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 randomly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integrated </a:t>
            </a:r>
            <a:r>
              <a:rPr kumimoji="0" lang="en-GB" altLang="zh-CN" sz="10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Neo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plasmid. In contrast to the 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L1 and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 assay described in the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upplementary Figure 1, these </a:t>
            </a:r>
            <a:r>
              <a:rPr kumimoji="0" lang="en-GB" altLang="zh-CN" sz="10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NeoR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colonies do not depend on </a:t>
            </a:r>
            <a:r>
              <a:rPr kumimoji="0" lang="en-GB" altLang="zh-CN" sz="1000" b="0" i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de novo </a:t>
            </a:r>
            <a:r>
              <a:rPr kumimoji="0" lang="en-GB" altLang="zh-CN" sz="10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.</a:t>
            </a:r>
            <a:endParaRPr kumimoji="0" lang="en-GB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98437" y="4876800"/>
            <a:ext cx="5750292" cy="1631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upplementary Figure </a:t>
            </a:r>
            <a:r>
              <a:rPr lang="en-GB" altLang="zh-CN" sz="10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3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.</a:t>
            </a:r>
            <a:r>
              <a:rPr kumimoji="0" lang="en-GB" altLang="zh-CN" sz="10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MT1 effect on </a:t>
            </a:r>
            <a:r>
              <a:rPr kumimoji="0" lang="en-GB" altLang="zh-CN" sz="1000" b="1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1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is specific</a:t>
            </a:r>
            <a:r>
              <a:rPr kumimoji="0" lang="en-GB" altLang="zh-CN" sz="10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o MT1 function.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Luzindole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treatments were performed as described in 2A. 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L1-driven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lu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in the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resence of the control plasmid is not affected by melatonin receptor antagonist (left panel top row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nd right panel grey bars), but it is increased when the treatment is combined with MT1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overexpress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(left panel bottom row and right panel black bars).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GB" altLang="zh-CN" sz="1000" dirty="0" smtClean="0">
              <a:latin typeface="Arial" pitchFamily="34" charset="0"/>
              <a:ea typeface="SimSun" pitchFamily="2" charset="-122"/>
              <a:cs typeface="Arial" pitchFamily="34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B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Luzindole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treatments and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cotransfect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of L1 with MT1 expression plasmid do not affect cell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iability and colony formation in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Hela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cells. Colony numbers obtained for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etrotranspositio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and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oxicity without any treatment with melatonin receptor antagonist are set as 100%. Error bars are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tandard deviation; asterisks indicate statistically significant differences by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test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.</a:t>
            </a:r>
            <a:endParaRPr kumimoji="0" lang="en-GB" altLang="zh-CN" sz="10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4637" y="838200"/>
            <a:ext cx="5641848" cy="38130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0" y="9144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2895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98437" y="0"/>
            <a:ext cx="2568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3. </a:t>
            </a:r>
            <a:endParaRPr lang="en-US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4637" y="762000"/>
            <a:ext cx="4572000" cy="28252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50837" y="3733800"/>
            <a:ext cx="4976042" cy="11695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upplementary Figure </a:t>
            </a:r>
            <a:r>
              <a:rPr lang="en-GB" altLang="zh-CN" sz="10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4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.</a:t>
            </a:r>
            <a:r>
              <a:rPr kumimoji="0" lang="en-GB" altLang="zh-CN" sz="10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L1 mRNA stability in </a:t>
            </a:r>
            <a:r>
              <a:rPr kumimoji="0" lang="en-GB" altLang="zh-CN" sz="1000" b="1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HeLa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and NIH 3T3 cells.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Hela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and NIH 3T3 cells transiently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ransfected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with an L1 expression plasmid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were treated 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24 hours </a:t>
            </a:r>
            <a:r>
              <a:rPr lang="en-GB" altLang="zh-CN" sz="10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posttransfection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w</a:t>
            </a:r>
            <a:r>
              <a:rPr lang="en-GB" altLang="zh-CN" sz="1000" baseline="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ith 75 </a:t>
            </a:r>
            <a:r>
              <a:rPr lang="en-GB" altLang="zh-CN" sz="1000" baseline="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ug</a:t>
            </a:r>
            <a:r>
              <a:rPr lang="en-GB" altLang="zh-CN" sz="1000" baseline="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/ml of </a:t>
            </a:r>
            <a:r>
              <a:rPr lang="en-GB" altLang="zh-CN" sz="1000" baseline="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ctinomycin</a:t>
            </a:r>
            <a:r>
              <a:rPr lang="en-GB" altLang="zh-CN" sz="1000" baseline="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D for 2, 4,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baseline="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and 8h. Collected RNA was 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analyzed by northern  blot with a strand-specific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RNA probe complementary to the 0-97bp r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egion of the L1 5’UTR as described.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Numbers below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images represent average (N=2) amount of the full-length </a:t>
            </a: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L1 mRNA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for each time point relative to the untreated control (0h).</a:t>
            </a:r>
            <a:r>
              <a:rPr kumimoji="0" lang="en-GB" altLang="zh-CN" sz="1000" b="0" i="0" u="none" strike="noStrike" cap="none" normalizeH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FL1 is full-length L1 mRNA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8437" y="0"/>
            <a:ext cx="2568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4. 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960437" y="3017520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actin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8437" y="1600200"/>
            <a:ext cx="5334000" cy="2019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Supplementary Figure 5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2237" y="4114800"/>
            <a:ext cx="5662127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ry figure 5. Melatonin receptor 1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overexpression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suppresses L1 ORF1p </a:t>
            </a:r>
          </a:p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in immortalized human fibroblasts.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Western blot analysis of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lysate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from immortalized human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fibroblasts  (GM04429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oriel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 transiently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ransfecte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with L1 expression plasmids and with or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without MT1 expression plasmid (labeled MT1 and control, respectively). Very low ORF1p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signal is detected when the L1 expression plasmid is co-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ransfecte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with the MT1 expression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plasmid in three independent experiments.  </a:t>
            </a:r>
            <a:endParaRPr lang="en-GB" sz="1000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Supplementary Figure 6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036637" y="1447800"/>
            <a:ext cx="3733800" cy="2209799"/>
            <a:chOff x="249138" y="1143000"/>
            <a:chExt cx="5138836" cy="2849710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808037" y="1143000"/>
              <a:ext cx="4579937" cy="2751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Box 34"/>
            <p:cNvSpPr txBox="1">
              <a:spLocks noChangeArrowheads="1"/>
            </p:cNvSpPr>
            <p:nvPr/>
          </p:nvSpPr>
          <p:spPr bwMode="auto">
            <a:xfrm rot="16200000">
              <a:off x="-613438" y="2202107"/>
              <a:ext cx="2186817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 L1 </a:t>
              </a:r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retrotransposition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,</a:t>
              </a:r>
            </a:p>
            <a:p>
              <a:pPr algn="ctr"/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BlastR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or </a:t>
              </a:r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NeoR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colonies,%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225275" y="3609536"/>
              <a:ext cx="4055092" cy="38317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 CMV/</a:t>
              </a:r>
              <a:r>
                <a:rPr lang="en-US" sz="1400" b="1" dirty="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L1Blast            </a:t>
              </a:r>
              <a:r>
                <a:rPr lang="en-US" sz="1400" b="1" dirty="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CMV/L1Neo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122237" y="4267200"/>
            <a:ext cx="5700600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ry figure 6. Melatonin receptor 1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overexpression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suppresses L1 </a:t>
            </a:r>
          </a:p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retrotransposition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regardless of the promoter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cells  transiently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ransfecte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with L1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expression plasmids and  with or without MT1 expression plasmid. CMV/</a:t>
            </a:r>
            <a:r>
              <a:rPr lang="en-US" sz="1000" dirty="0" smtClean="0">
                <a:latin typeface="Symbol" pitchFamily="18" charset="2"/>
                <a:cs typeface="Arial" pitchFamily="34" charset="0"/>
              </a:rPr>
              <a:t>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L1Blast  is  an L1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expression plasmid driven by the CMV promoter. This plasmid does not contain an L1 5’UTR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harboring L1 promoter. The L1 is tagged with a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lasticidi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resistance gene (blast). </a:t>
            </a:r>
            <a:r>
              <a:rPr lang="en-US" sz="1000" dirty="0" smtClean="0">
                <a:latin typeface="Symbol" pitchFamily="18" charset="2"/>
                <a:cs typeface="Arial" pitchFamily="34" charset="0"/>
              </a:rPr>
              <a:t>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CMV/L1Neo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is an L1 expression plasmid  driven by the L1 promoter located within the L1 5’UTR. This plasmid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does not contain the CMV promoter. The L1 in this expression plasmid is tagged with a neomycin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resistance gene (Neo).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T1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overexpression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 significantly reduces L1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retrotransposition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 driven by 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either the CMV or L1 promoters. Error bars are standard deviation.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endParaRPr lang="en-GB" sz="1000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228600"/>
            <a:ext cx="2568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7. </a:t>
            </a:r>
            <a:endParaRPr lang="en-US" b="1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65237" y="2743200"/>
            <a:ext cx="3733800" cy="19926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122237" y="4953000"/>
            <a:ext cx="6080511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ry figure 7. A.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Alu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retrotrotransposition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supported by </a:t>
            </a:r>
            <a:r>
              <a:rPr lang="en-US" sz="1000" dirty="0" smtClean="0">
                <a:latin typeface="Symbol" pitchFamily="18" charset="2"/>
                <a:cs typeface="Arial" pitchFamily="34" charset="0"/>
              </a:rPr>
              <a:t>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CMVL1 (without a tag) in the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presence and absence of MT1 expression.  Treatment with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luzindol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vercomes the suppressive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effect MT1 on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Alu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retrotranspositio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in a dose-dependent manner.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Error bars are standard deviation. </a:t>
            </a:r>
          </a:p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B. Toxicity assay in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cells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ransfecte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with </a:t>
            </a:r>
            <a:r>
              <a:rPr lang="en-US" sz="1000" dirty="0" smtClean="0">
                <a:latin typeface="Symbol" pitchFamily="18" charset="2"/>
                <a:cs typeface="Arial" pitchFamily="34" charset="0"/>
              </a:rPr>
              <a:t>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CMVL1 and empty or MT1 expression plasmids 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and treated with increasing amounts of  melatonin receptor antagonist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luzindol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(0, 10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-7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10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-6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or 10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-5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M). 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Error bars are standard deviation; no  statistically significant differences  was detected by the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ttest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00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12837" y="609600"/>
            <a:ext cx="3810000" cy="2060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427037" y="2667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27037" y="685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27037" y="457200"/>
            <a:ext cx="5334000" cy="5311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Supplementary Figure 8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50837" y="381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50837" y="1752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50837" y="4038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0" y="5867400"/>
            <a:ext cx="5917004" cy="11695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upplementary figure </a:t>
            </a:r>
            <a:r>
              <a:rPr lang="en-GB" altLang="zh-CN" sz="10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8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. L1 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mRNA expression is regulated by melatonin in human tissue-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zh-CN" sz="10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Isolated </a:t>
            </a:r>
            <a:r>
              <a:rPr lang="en-GB" altLang="zh-CN" sz="10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xenograft</a:t>
            </a:r>
            <a:r>
              <a:rPr lang="en-GB" altLang="zh-CN" sz="10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model of 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rostate cancer in nude rats. A.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chematic representation of L1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nd primers used for RT-PCR. 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B.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Validation of primer specificity. Results of PCR amplification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using rat (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R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) or human (Hs) DNA as template. NC is negative control, M is marker.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C.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Detection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of L1 mRNA by RT-PCR in DNA samples collected from the prostate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xenografts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erfused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in</a:t>
            </a:r>
            <a:r>
              <a:rPr kumimoji="0" lang="en-GB" altLang="zh-CN" sz="1000" b="0" i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situ</a:t>
            </a:r>
            <a:r>
              <a:rPr kumimoji="0" lang="en-GB" altLang="zh-CN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s described in figure 1. RT is reverse transcriptase, L1 and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cti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are L1- and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ctin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-specific primers,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C3 is RNA from PC3 cells used to generate </a:t>
            </a:r>
            <a:r>
              <a:rPr kumimoji="0" lang="en-GB" altLang="zh-CN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xenograft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tumours. M is marker, NC is</a:t>
            </a:r>
            <a:r>
              <a:rPr kumimoji="0" lang="en-GB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GB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negative control. </a:t>
            </a:r>
            <a:endParaRPr kumimoji="0" lang="en-GB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3</TotalTime>
  <Words>1060</Words>
  <Application>Microsoft Office PowerPoint</Application>
  <PresentationFormat>Custom</PresentationFormat>
  <Paragraphs>90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ctoria</dc:creator>
  <cp:lastModifiedBy>M. Bernardes Silva</cp:lastModifiedBy>
  <cp:revision>333</cp:revision>
  <dcterms:created xsi:type="dcterms:W3CDTF">2013-04-16T19:13:34Z</dcterms:created>
  <dcterms:modified xsi:type="dcterms:W3CDTF">2014-05-01T09:26:14Z</dcterms:modified>
</cp:coreProperties>
</file>